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0" r:id="rId4"/>
    <p:sldId id="257" r:id="rId5"/>
    <p:sldId id="25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50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B79548-6F20-4410-BEA5-8EDE928FF2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7D9EAB4-9664-4CBC-8A88-460AB32E92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CD29AE-735E-4301-864F-CDFC155493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48ED-2126-421E-BAA7-46489C00D685}" type="datetimeFigureOut">
              <a:rPr lang="en-IN" smtClean="0"/>
              <a:t>17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31ABD4-A5E9-42FE-8C6F-CE4E3DD53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BD27D0-0050-4E28-8858-716BC8E32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A2F58-F008-4DB6-992F-2578D57A4E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527799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3C11A4-0528-4B34-9318-E5227698FE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F484982-F350-4AA5-8AFE-2DD006649D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FD179D-A4B2-4819-9702-5946C8854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48ED-2126-421E-BAA7-46489C00D685}" type="datetimeFigureOut">
              <a:rPr lang="en-IN" smtClean="0"/>
              <a:t>17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2E21D8-7CB3-47E0-8635-4C36CB0DC9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57185F-E656-441E-A7BD-1A9051D1D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A2F58-F008-4DB6-992F-2578D57A4E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46500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EA22E0-8D45-4C4F-B360-FEDD387E9F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A2FEC1-AE95-4B97-9FB3-A3163BCF1F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221399-29D7-4C72-AD06-383D134251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48ED-2126-421E-BAA7-46489C00D685}" type="datetimeFigureOut">
              <a:rPr lang="en-IN" smtClean="0"/>
              <a:t>17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E2E374-76B9-40A6-9D19-D2DDF3BA8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56F760-56E2-43CE-9DA5-4FB328F2D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A2F58-F008-4DB6-992F-2578D57A4E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36939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02D7F3-565F-4664-BFC9-007766EC10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176A3C-BE87-4ABD-B6DB-2F6C07D67B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40F7C9-DE77-4600-9F94-C870DEB34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48ED-2126-421E-BAA7-46489C00D685}" type="datetimeFigureOut">
              <a:rPr lang="en-IN" smtClean="0"/>
              <a:t>17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D593AA-EBEC-4290-BE46-386C2C9E10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980A3D-EF7A-4291-9B45-378CF0097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A2F58-F008-4DB6-992F-2578D57A4E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9808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EE2AD8-38EB-4E58-B8F2-472931B28F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61C17C-9E8B-40FF-BFC9-6D9C54594F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9390C2-C7B7-42AA-9C29-85B598713C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48ED-2126-421E-BAA7-46489C00D685}" type="datetimeFigureOut">
              <a:rPr lang="en-IN" smtClean="0"/>
              <a:t>17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040CD1-E1F9-4340-B19F-8AF77D62E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FDFBAA-8B53-448A-8A0A-70E2CBA5F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A2F58-F008-4DB6-992F-2578D57A4E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57477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E3ADD1-4B57-4B5E-8044-3C3B4BBC8A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B5D378-F784-454F-A4B5-6636AAB5F7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879B1D-6364-462B-BB2B-D74F5E681E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E110C9-8BA4-4FC4-BC6F-2664D9080B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48ED-2126-421E-BAA7-46489C00D685}" type="datetimeFigureOut">
              <a:rPr lang="en-IN" smtClean="0"/>
              <a:t>17-04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44D106-1FC6-48E5-8958-B3416EB9D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A9E61E-622B-4730-8078-5358105B1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A2F58-F008-4DB6-992F-2578D57A4E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82099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013E42-D18F-42EA-BCB1-80AC64E6CB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C4E69F-3C31-4EAA-B94D-D32F45B10A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07A6E4D-1FDD-400D-B366-6DB5F76AD9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691AD32-C742-42E6-A78D-F2C641AB74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13AC38B-F39C-4BC9-979E-437BD406F3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D3729A4-A17D-4E79-BB87-5261BE09A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48ED-2126-421E-BAA7-46489C00D685}" type="datetimeFigureOut">
              <a:rPr lang="en-IN" smtClean="0"/>
              <a:t>17-04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760D04-DCD0-4BCD-9C98-74B6891D9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D6E8823-E78B-4BEA-9E19-292171416B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A2F58-F008-4DB6-992F-2578D57A4E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753346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49B18A-E0B1-4FAC-80FF-EE913DD8D6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F8E814F-BCA2-4796-89B1-31C5A5260E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48ED-2126-421E-BAA7-46489C00D685}" type="datetimeFigureOut">
              <a:rPr lang="en-IN" smtClean="0"/>
              <a:t>17-04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1FFEAC-87C8-4A98-AED6-406DE1393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D733478-19A6-459A-8916-0E3A245F3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A2F58-F008-4DB6-992F-2578D57A4E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80218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1086185-FD87-4ACC-B102-A1D70F467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48ED-2126-421E-BAA7-46489C00D685}" type="datetimeFigureOut">
              <a:rPr lang="en-IN" smtClean="0"/>
              <a:t>17-04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048D26A-0AA5-4FDD-A21D-C7E94C290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F860A6-4AF2-45DF-8C10-CCA72B55F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A2F58-F008-4DB6-992F-2578D57A4E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37604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60FD9E-F87D-4049-A2CA-3BE1BBBB7C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CB7845-7183-4CBC-943D-F12A6993E7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96F489-3BAE-4C17-B427-E2C6F2B7E5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0DFDB0-3D19-41BA-AD5E-486FD4438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48ED-2126-421E-BAA7-46489C00D685}" type="datetimeFigureOut">
              <a:rPr lang="en-IN" smtClean="0"/>
              <a:t>17-04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B335D0-111D-410A-A4DC-D104A43417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53F950-A562-47BC-915B-71E03702E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A2F58-F008-4DB6-992F-2578D57A4E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32318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53661A-A093-475E-85B0-C4A3D5CA4C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010FD32-2424-445A-987A-C25702C23C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12629A-B2A0-46B6-B6E8-8051BF270C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8497B6-9106-42C1-91C5-EA315D3CD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48ED-2126-421E-BAA7-46489C00D685}" type="datetimeFigureOut">
              <a:rPr lang="en-IN" smtClean="0"/>
              <a:t>17-04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5D7823-C68A-4031-8169-F43AD4B595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2AB4DF-61F0-47C0-8003-8C33DD0245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7A2F58-F008-4DB6-992F-2578D57A4E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44135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DB8A24F-6776-4580-AEEC-9D22174094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9446CF-14EB-407F-86B5-0FE5A6081D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1DFEC7-778C-43A6-938B-131FBC7AFF3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848ED-2126-421E-BAA7-46489C00D685}" type="datetimeFigureOut">
              <a:rPr lang="en-IN" smtClean="0"/>
              <a:t>17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2BF943-EC1E-405D-8873-7CA380D88F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32C566-88A4-470D-A40A-680937D2EC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7A2F58-F008-4DB6-992F-2578D57A4E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05588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CDE6CD09-3BED-4A7D-827E-C8D3D69C92B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1" t="1" r="-566" b="7345"/>
          <a:stretch/>
        </p:blipFill>
        <p:spPr>
          <a:xfrm>
            <a:off x="1049867" y="251871"/>
            <a:ext cx="9194799" cy="6354258"/>
          </a:xfrm>
          <a:prstGeom prst="rect">
            <a:avLst/>
          </a:prstGeom>
        </p:spPr>
      </p:pic>
      <p:grpSp>
        <p:nvGrpSpPr>
          <p:cNvPr id="27" name="Group 26">
            <a:extLst>
              <a:ext uri="{FF2B5EF4-FFF2-40B4-BE49-F238E27FC236}">
                <a16:creationId xmlns:a16="http://schemas.microsoft.com/office/drawing/2014/main" id="{0B960A29-5A7C-4191-A90C-19784B4347EA}"/>
              </a:ext>
            </a:extLst>
          </p:cNvPr>
          <p:cNvGrpSpPr/>
          <p:nvPr/>
        </p:nvGrpSpPr>
        <p:grpSpPr>
          <a:xfrm>
            <a:off x="3728147" y="249147"/>
            <a:ext cx="3821201" cy="388328"/>
            <a:chOff x="7097762" y="4370828"/>
            <a:chExt cx="3821201" cy="388328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A042D2B-C030-46DE-902A-6A611C73D0E1}"/>
                </a:ext>
              </a:extLst>
            </p:cNvPr>
            <p:cNvSpPr txBox="1"/>
            <p:nvPr/>
          </p:nvSpPr>
          <p:spPr>
            <a:xfrm>
              <a:off x="10253396" y="4370828"/>
              <a:ext cx="6655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NL20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CD9F545-0B3D-4E2D-BF58-74031C22C085}"/>
                </a:ext>
              </a:extLst>
            </p:cNvPr>
            <p:cNvSpPr txBox="1"/>
            <p:nvPr/>
          </p:nvSpPr>
          <p:spPr>
            <a:xfrm>
              <a:off x="8897237" y="4389824"/>
              <a:ext cx="8236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SKMES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B85DF59-16A8-4270-AEC8-FAB7D404E690}"/>
                </a:ext>
              </a:extLst>
            </p:cNvPr>
            <p:cNvSpPr txBox="1"/>
            <p:nvPr/>
          </p:nvSpPr>
          <p:spPr>
            <a:xfrm>
              <a:off x="9616509" y="4389753"/>
              <a:ext cx="6687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A549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FBA900B-C7F6-426A-8E61-DC06CCCA9DE3}"/>
                </a:ext>
              </a:extLst>
            </p:cNvPr>
            <p:cNvSpPr txBox="1"/>
            <p:nvPr/>
          </p:nvSpPr>
          <p:spPr>
            <a:xfrm>
              <a:off x="7097762" y="4376314"/>
              <a:ext cx="6655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NL2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4C4A0CC-7EFD-4CB4-B929-95E04D595ACD}"/>
                </a:ext>
              </a:extLst>
            </p:cNvPr>
            <p:cNvSpPr txBox="1"/>
            <p:nvPr/>
          </p:nvSpPr>
          <p:spPr>
            <a:xfrm>
              <a:off x="7694601" y="4376314"/>
              <a:ext cx="8236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SKMES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FE88EC8-4564-482C-8FA7-469D26CEF23C}"/>
                </a:ext>
              </a:extLst>
            </p:cNvPr>
            <p:cNvSpPr txBox="1"/>
            <p:nvPr/>
          </p:nvSpPr>
          <p:spPr>
            <a:xfrm>
              <a:off x="8364251" y="4383069"/>
              <a:ext cx="6687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A549</a:t>
              </a: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4AB2AD76-3336-4EEF-83C7-CD1D4296EB02}"/>
              </a:ext>
            </a:extLst>
          </p:cNvPr>
          <p:cNvSpPr txBox="1"/>
          <p:nvPr/>
        </p:nvSpPr>
        <p:spPr>
          <a:xfrm>
            <a:off x="5278408" y="3380632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CD6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B2D1E50-A7B1-4E18-A4F2-484DD27A3A5A}"/>
              </a:ext>
            </a:extLst>
          </p:cNvPr>
          <p:cNvSpPr txBox="1"/>
          <p:nvPr/>
        </p:nvSpPr>
        <p:spPr>
          <a:xfrm>
            <a:off x="4866549" y="4182604"/>
            <a:ext cx="22071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Figure 1 Western blo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63D35A9-D235-48E6-B848-D4A1CF6E3CBE}"/>
              </a:ext>
            </a:extLst>
          </p:cNvPr>
          <p:cNvSpPr txBox="1"/>
          <p:nvPr/>
        </p:nvSpPr>
        <p:spPr>
          <a:xfrm>
            <a:off x="4398894" y="0"/>
            <a:ext cx="1023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Exosom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3169E1F-29DA-4704-8A41-125E140C033B}"/>
              </a:ext>
            </a:extLst>
          </p:cNvPr>
          <p:cNvSpPr txBox="1"/>
          <p:nvPr/>
        </p:nvSpPr>
        <p:spPr>
          <a:xfrm>
            <a:off x="6005608" y="0"/>
            <a:ext cx="1125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Cell lysate</a:t>
            </a:r>
          </a:p>
        </p:txBody>
      </p:sp>
    </p:spTree>
    <p:extLst>
      <p:ext uri="{BB962C8B-B14F-4D97-AF65-F5344CB8AC3E}">
        <p14:creationId xmlns:p14="http://schemas.microsoft.com/office/powerpoint/2010/main" val="19033222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801D3E7-E8B6-47B0-AEB6-8A65663C74A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91" t="-10831" b="-1285"/>
          <a:stretch/>
        </p:blipFill>
        <p:spPr>
          <a:xfrm flipV="1">
            <a:off x="1668544" y="410066"/>
            <a:ext cx="7711186" cy="644793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F62107C-6FB5-44A9-A410-297D8B84CF5F}"/>
              </a:ext>
            </a:extLst>
          </p:cNvPr>
          <p:cNvSpPr txBox="1"/>
          <p:nvPr/>
        </p:nvSpPr>
        <p:spPr>
          <a:xfrm>
            <a:off x="6643366" y="4332270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CD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49084C4-1D1C-4A82-9906-1FCAB8FB8D8B}"/>
              </a:ext>
            </a:extLst>
          </p:cNvPr>
          <p:cNvSpPr txBox="1"/>
          <p:nvPr/>
        </p:nvSpPr>
        <p:spPr>
          <a:xfrm>
            <a:off x="4858082" y="5204942"/>
            <a:ext cx="22071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Figure 1 Western blot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46A20A08-AA1E-48CE-9113-E0471898DDAD}"/>
              </a:ext>
            </a:extLst>
          </p:cNvPr>
          <p:cNvGrpSpPr/>
          <p:nvPr/>
        </p:nvGrpSpPr>
        <p:grpSpPr>
          <a:xfrm>
            <a:off x="5185382" y="1953757"/>
            <a:ext cx="3233844" cy="569165"/>
            <a:chOff x="5238128" y="556866"/>
            <a:chExt cx="3233844" cy="569165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FD3EEFDB-FB1F-41FD-BAFF-1192761750A1}"/>
                </a:ext>
              </a:extLst>
            </p:cNvPr>
            <p:cNvGrpSpPr/>
            <p:nvPr/>
          </p:nvGrpSpPr>
          <p:grpSpPr>
            <a:xfrm>
              <a:off x="5238128" y="811499"/>
              <a:ext cx="3233844" cy="314532"/>
              <a:chOff x="7267448" y="4376314"/>
              <a:chExt cx="3233844" cy="314532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E53126DD-BBB2-4E6D-BF1A-1593C8B1663D}"/>
                  </a:ext>
                </a:extLst>
              </p:cNvPr>
              <p:cNvSpPr txBox="1"/>
              <p:nvPr/>
            </p:nvSpPr>
            <p:spPr>
              <a:xfrm>
                <a:off x="8945167" y="4378807"/>
                <a:ext cx="68146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dirty="0"/>
                  <a:t>SKMES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9E336A3B-3A95-4049-9621-B3936EF940D8}"/>
                  </a:ext>
                </a:extLst>
              </p:cNvPr>
              <p:cNvSpPr txBox="1"/>
              <p:nvPr/>
            </p:nvSpPr>
            <p:spPr>
              <a:xfrm>
                <a:off x="9500376" y="4376314"/>
                <a:ext cx="5629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dirty="0"/>
                  <a:t>A549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290A241B-7072-4F33-B573-1DC05BEABDD2}"/>
                  </a:ext>
                </a:extLst>
              </p:cNvPr>
              <p:cNvSpPr txBox="1"/>
              <p:nvPr/>
            </p:nvSpPr>
            <p:spPr>
              <a:xfrm>
                <a:off x="9943126" y="4383069"/>
                <a:ext cx="55816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dirty="0"/>
                  <a:t>NL20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86BB8C99-50A1-4D1F-A700-C2198645C988}"/>
                  </a:ext>
                </a:extLst>
              </p:cNvPr>
              <p:cNvSpPr txBox="1"/>
              <p:nvPr/>
            </p:nvSpPr>
            <p:spPr>
              <a:xfrm>
                <a:off x="7267448" y="4376314"/>
                <a:ext cx="55816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dirty="0"/>
                  <a:t>NL20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28E42ED2-1A92-4CE9-A67A-4400EA2D9F84}"/>
                  </a:ext>
                </a:extLst>
              </p:cNvPr>
              <p:cNvSpPr txBox="1"/>
              <p:nvPr/>
            </p:nvSpPr>
            <p:spPr>
              <a:xfrm>
                <a:off x="7770017" y="4376314"/>
                <a:ext cx="68146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dirty="0"/>
                  <a:t>SKMES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9EDC031-0219-42A3-B46C-2F6E694DB6ED}"/>
                  </a:ext>
                </a:extLst>
              </p:cNvPr>
              <p:cNvSpPr txBox="1"/>
              <p:nvPr/>
            </p:nvSpPr>
            <p:spPr>
              <a:xfrm>
                <a:off x="8420813" y="4383069"/>
                <a:ext cx="5629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dirty="0"/>
                  <a:t>A549</a:t>
                </a:r>
              </a:p>
            </p:txBody>
          </p: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3DBB1DE-431F-4BFF-A5B4-2E0D4C7A1AA4}"/>
                </a:ext>
              </a:extLst>
            </p:cNvPr>
            <p:cNvSpPr txBox="1"/>
            <p:nvPr/>
          </p:nvSpPr>
          <p:spPr>
            <a:xfrm>
              <a:off x="5739189" y="556866"/>
              <a:ext cx="8386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dirty="0"/>
                <a:t>Exosome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73EA5E73-6D3A-489E-A621-672430902588}"/>
                </a:ext>
              </a:extLst>
            </p:cNvPr>
            <p:cNvSpPr txBox="1"/>
            <p:nvPr/>
          </p:nvSpPr>
          <p:spPr>
            <a:xfrm>
              <a:off x="7345903" y="556866"/>
              <a:ext cx="9199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dirty="0"/>
                <a:t>Cell lysat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430921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9F864033-413D-4A12-ABBC-015D9DA26C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0398" y="350938"/>
            <a:ext cx="8445500" cy="6350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61EA9ED-3261-47F5-8690-275180B27F95}"/>
              </a:ext>
            </a:extLst>
          </p:cNvPr>
          <p:cNvSpPr txBox="1"/>
          <p:nvPr/>
        </p:nvSpPr>
        <p:spPr>
          <a:xfrm>
            <a:off x="5499940" y="5010707"/>
            <a:ext cx="979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Calnex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998B234-18F6-43ED-AFC3-C7563C736D70}"/>
              </a:ext>
            </a:extLst>
          </p:cNvPr>
          <p:cNvSpPr txBox="1"/>
          <p:nvPr/>
        </p:nvSpPr>
        <p:spPr>
          <a:xfrm>
            <a:off x="4968149" y="6229932"/>
            <a:ext cx="22071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Figure 1 Western blot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6CCB408D-A588-4FAA-8934-A1FF6FE4C506}"/>
              </a:ext>
            </a:extLst>
          </p:cNvPr>
          <p:cNvGrpSpPr/>
          <p:nvPr/>
        </p:nvGrpSpPr>
        <p:grpSpPr>
          <a:xfrm>
            <a:off x="4562113" y="3174089"/>
            <a:ext cx="3703913" cy="386885"/>
            <a:chOff x="7097762" y="4365516"/>
            <a:chExt cx="3703913" cy="386885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D06236A-54AD-4BFA-A07B-8D8EFF9E18A6}"/>
                </a:ext>
              </a:extLst>
            </p:cNvPr>
            <p:cNvSpPr txBox="1"/>
            <p:nvPr/>
          </p:nvSpPr>
          <p:spPr>
            <a:xfrm>
              <a:off x="10136108" y="4380327"/>
              <a:ext cx="6655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NL2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B78DED1-1A94-40E7-ACA9-7CF8BAF9CDD6}"/>
                </a:ext>
              </a:extLst>
            </p:cNvPr>
            <p:cNvSpPr txBox="1"/>
            <p:nvPr/>
          </p:nvSpPr>
          <p:spPr>
            <a:xfrm>
              <a:off x="8948497" y="4369559"/>
              <a:ext cx="8236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SKMES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13B99E9-D171-4E8A-9B1E-4F4DD3560EC2}"/>
                </a:ext>
              </a:extLst>
            </p:cNvPr>
            <p:cNvSpPr txBox="1"/>
            <p:nvPr/>
          </p:nvSpPr>
          <p:spPr>
            <a:xfrm>
              <a:off x="9611364" y="4365516"/>
              <a:ext cx="6687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A549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16081E6-4C4E-4EB7-8DFC-088F3E82600D}"/>
                </a:ext>
              </a:extLst>
            </p:cNvPr>
            <p:cNvSpPr txBox="1"/>
            <p:nvPr/>
          </p:nvSpPr>
          <p:spPr>
            <a:xfrm>
              <a:off x="7097762" y="4376314"/>
              <a:ext cx="6655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NL2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7519974-003B-4E4F-801D-C5F9FC4EFCA5}"/>
                </a:ext>
              </a:extLst>
            </p:cNvPr>
            <p:cNvSpPr txBox="1"/>
            <p:nvPr/>
          </p:nvSpPr>
          <p:spPr>
            <a:xfrm>
              <a:off x="7694601" y="4376314"/>
              <a:ext cx="8236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SKMES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C7FA565-A068-403B-972D-3600B66D7DAB}"/>
                </a:ext>
              </a:extLst>
            </p:cNvPr>
            <p:cNvSpPr txBox="1"/>
            <p:nvPr/>
          </p:nvSpPr>
          <p:spPr>
            <a:xfrm>
              <a:off x="8364251" y="4383069"/>
              <a:ext cx="6687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A549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33E0734D-B5F1-4EEB-BD80-F48B19EA7559}"/>
              </a:ext>
            </a:extLst>
          </p:cNvPr>
          <p:cNvSpPr txBox="1"/>
          <p:nvPr/>
        </p:nvSpPr>
        <p:spPr>
          <a:xfrm>
            <a:off x="5171469" y="2811256"/>
            <a:ext cx="1023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Exosom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6C06C03-28B9-4AD0-8D65-D05CE88B42AE}"/>
              </a:ext>
            </a:extLst>
          </p:cNvPr>
          <p:cNvSpPr txBox="1"/>
          <p:nvPr/>
        </p:nvSpPr>
        <p:spPr>
          <a:xfrm>
            <a:off x="6793330" y="2808800"/>
            <a:ext cx="1125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Cell lysate</a:t>
            </a:r>
          </a:p>
        </p:txBody>
      </p:sp>
    </p:spTree>
    <p:extLst>
      <p:ext uri="{BB962C8B-B14F-4D97-AF65-F5344CB8AC3E}">
        <p14:creationId xmlns:p14="http://schemas.microsoft.com/office/powerpoint/2010/main" val="27142189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7BB6AA5-4686-4500-9BCA-E64C8ED150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0864" y="443346"/>
            <a:ext cx="7606146" cy="507076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7559754-AF15-4334-850C-3CECD4B3D84B}"/>
              </a:ext>
            </a:extLst>
          </p:cNvPr>
          <p:cNvSpPr txBox="1"/>
          <p:nvPr/>
        </p:nvSpPr>
        <p:spPr>
          <a:xfrm>
            <a:off x="5200073" y="5892800"/>
            <a:ext cx="2455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TEM image of exosom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2B32963-C49A-4BF1-8F5C-83F2F8F1A386}"/>
              </a:ext>
            </a:extLst>
          </p:cNvPr>
          <p:cNvSpPr txBox="1"/>
          <p:nvPr/>
        </p:nvSpPr>
        <p:spPr>
          <a:xfrm>
            <a:off x="4355541" y="5892800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Figure 1</a:t>
            </a:r>
          </a:p>
        </p:txBody>
      </p:sp>
    </p:spTree>
    <p:extLst>
      <p:ext uri="{BB962C8B-B14F-4D97-AF65-F5344CB8AC3E}">
        <p14:creationId xmlns:p14="http://schemas.microsoft.com/office/powerpoint/2010/main" val="14288871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8C1E71D-BB37-416F-BA40-2A5DCBCC6A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6863" y="443345"/>
            <a:ext cx="4591853" cy="404552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C65CFAA-C01B-49C3-8404-B1569738771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3283" y="443345"/>
            <a:ext cx="4591855" cy="404552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F10712F-9E04-4FF1-B1E4-D53BB70E475E}"/>
              </a:ext>
            </a:extLst>
          </p:cNvPr>
          <p:cNvSpPr txBox="1"/>
          <p:nvPr/>
        </p:nvSpPr>
        <p:spPr>
          <a:xfrm>
            <a:off x="1930400" y="4627418"/>
            <a:ext cx="3360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Exosome uptake – PKH unlabelle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3B83627-C3CE-44BC-8B37-C08B148D88E2}"/>
              </a:ext>
            </a:extLst>
          </p:cNvPr>
          <p:cNvSpPr txBox="1"/>
          <p:nvPr/>
        </p:nvSpPr>
        <p:spPr>
          <a:xfrm>
            <a:off x="6834909" y="4627418"/>
            <a:ext cx="3116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Exosome uptake – PKH labell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699E81B-2835-4AA2-AF4F-A797A22966DF}"/>
              </a:ext>
            </a:extLst>
          </p:cNvPr>
          <p:cNvSpPr txBox="1"/>
          <p:nvPr/>
        </p:nvSpPr>
        <p:spPr>
          <a:xfrm>
            <a:off x="4858082" y="5204942"/>
            <a:ext cx="25203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Figure 2 exosome uptake</a:t>
            </a:r>
          </a:p>
        </p:txBody>
      </p:sp>
    </p:spTree>
    <p:extLst>
      <p:ext uri="{BB962C8B-B14F-4D97-AF65-F5344CB8AC3E}">
        <p14:creationId xmlns:p14="http://schemas.microsoft.com/office/powerpoint/2010/main" val="2189299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0</TotalTime>
  <Words>62</Words>
  <Application>Microsoft Office PowerPoint</Application>
  <PresentationFormat>Widescreen</PresentationFormat>
  <Paragraphs>3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fiza Padinharayil</dc:creator>
  <cp:lastModifiedBy>Hafiza Padinharayil</cp:lastModifiedBy>
  <cp:revision>10</cp:revision>
  <dcterms:created xsi:type="dcterms:W3CDTF">2025-01-09T04:11:21Z</dcterms:created>
  <dcterms:modified xsi:type="dcterms:W3CDTF">2025-04-17T11:17:50Z</dcterms:modified>
</cp:coreProperties>
</file>